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21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24" roundtripDataSignature="AMtx7mjDKvUu4ehPfBGlmVq44J59DoB5c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778" y="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customschemas.google.com/relationships/presentationmetadata" Target="metadata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7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Nº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6" name="Google Shape;86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Google Shape;176;p1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77" name="Google Shape;177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Google Shape;186;p1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87" name="Google Shape;187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6" name="Google Shape;196;p1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97" name="Google Shape;197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" name="Google Shape;206;p1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07" name="Google Shape;207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6" name="Google Shape;216;p1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17" name="Google Shape;217;p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6" name="Google Shape;226;p1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27" name="Google Shape;227;p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Google Shape;236;p1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37" name="Google Shape;237;p1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Google Shape;246;p1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47" name="Google Shape;247;p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" name="Google Shape;256;p1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57" name="Google Shape;257;p1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" name="Google Shape;266;p1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67" name="Google Shape;267;p1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68" name="Google Shape;268;p19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9</a:t>
            </a:fld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Google Shape;95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6" name="Google Shape;96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Google Shape;105;p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6" name="Google Shape;106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16" name="Google Shape;116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Google Shape;125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26" name="Google Shape;126;p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27" name="Google Shape;127;p5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5</a:t>
            </a:fld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Google Shape;136;p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37" name="Google Shape;137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Google Shape;146;p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7" name="Google Shape;147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Google Shape;156;p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57" name="Google Shape;157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Google Shape;166;p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67" name="Google Shape;167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a de título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21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21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8" name="Google Shape;18;p2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2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2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y texto vertical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30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30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3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3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3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vertical y texto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31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31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3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3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3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y objetos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2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2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2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2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2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ncabezado de sección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23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23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2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2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2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os objetos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2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2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24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2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2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2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ció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25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25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25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25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25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2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2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2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olo el título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2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2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2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n blanco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2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2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ido con título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8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8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1" name="Google Shape;61;p28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2" name="Google Shape;62;p2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n con título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9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9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9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9" name="Google Shape;69;p2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0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20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1.jp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3.jp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5.jp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7.jp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jp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9.jp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1.jp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jp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3.jp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jp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5.jp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jp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7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4.jp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6.jp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Google Shape;88;p1"/>
          <p:cNvSpPr txBox="1"/>
          <p:nvPr/>
        </p:nvSpPr>
        <p:spPr>
          <a:xfrm>
            <a:off x="1823953" y="1026367"/>
            <a:ext cx="248946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) GSE6575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9" name="Google Shape;89;p1"/>
          <p:cNvSpPr txBox="1"/>
          <p:nvPr/>
        </p:nvSpPr>
        <p:spPr>
          <a:xfrm>
            <a:off x="4888164" y="370277"/>
            <a:ext cx="2070776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utism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0" name="Google Shape;90;p1"/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incipal Component Analysis (PCA) plots of the whole set of genes in the dataset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 </a:t>
            </a:r>
            <a:endParaRPr/>
          </a:p>
        </p:txBody>
      </p:sp>
      <p:sp>
        <p:nvSpPr>
          <p:cNvPr id="91" name="Google Shape;91;p1"/>
          <p:cNvSpPr/>
          <p:nvPr/>
        </p:nvSpPr>
        <p:spPr>
          <a:xfrm>
            <a:off x="2510726" y="1462009"/>
            <a:ext cx="1090047" cy="244544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92" name="Google Shape;92;p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6387496" y="1584281"/>
            <a:ext cx="4836612" cy="4030510"/>
          </a:xfrm>
          <a:prstGeom prst="rect">
            <a:avLst/>
          </a:prstGeom>
          <a:noFill/>
          <a:ln>
            <a:noFill/>
          </a:ln>
        </p:spPr>
      </p:pic>
      <p:pic>
        <p:nvPicPr>
          <p:cNvPr id="93" name="Google Shape;93;p1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291497" y="1846263"/>
            <a:ext cx="6095999" cy="316547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Google Shape;179;p10"/>
          <p:cNvSpPr txBox="1"/>
          <p:nvPr/>
        </p:nvSpPr>
        <p:spPr>
          <a:xfrm>
            <a:off x="1823953" y="1026367"/>
            <a:ext cx="256980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j) GSE12654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0" name="Google Shape;180;p10"/>
          <p:cNvSpPr txBox="1"/>
          <p:nvPr/>
        </p:nvSpPr>
        <p:spPr>
          <a:xfrm>
            <a:off x="4888164" y="370277"/>
            <a:ext cx="297511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ajor depressive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1" name="Google Shape;181;p10"/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incipal Component Analysis (PCA) plots of the whole set of genes in the dataset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 </a:t>
            </a:r>
            <a:endParaRPr/>
          </a:p>
        </p:txBody>
      </p:sp>
      <p:sp>
        <p:nvSpPr>
          <p:cNvPr id="182" name="Google Shape;182;p10"/>
          <p:cNvSpPr/>
          <p:nvPr/>
        </p:nvSpPr>
        <p:spPr>
          <a:xfrm>
            <a:off x="2510726" y="1462009"/>
            <a:ext cx="1090047" cy="244544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83" name="Google Shape;183;p10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79719" y="2044700"/>
            <a:ext cx="5713853" cy="2967037"/>
          </a:xfrm>
          <a:prstGeom prst="rect">
            <a:avLst/>
          </a:prstGeom>
          <a:noFill/>
          <a:ln>
            <a:noFill/>
          </a:ln>
        </p:spPr>
      </p:pic>
      <p:sp>
        <p:nvSpPr>
          <p:cNvPr id="184" name="Google Shape;184;p10"/>
          <p:cNvSpPr txBox="1"/>
          <p:nvPr/>
        </p:nvSpPr>
        <p:spPr>
          <a:xfrm>
            <a:off x="6662056" y="2763080"/>
            <a:ext cx="4717143" cy="10156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6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o results</a:t>
            </a:r>
            <a:endParaRPr sz="6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Google Shape;189;p11"/>
          <p:cNvSpPr txBox="1"/>
          <p:nvPr/>
        </p:nvSpPr>
        <p:spPr>
          <a:xfrm>
            <a:off x="1823953" y="1026367"/>
            <a:ext cx="310982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k) GSE53987_HPC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0" name="Google Shape;190;p11"/>
          <p:cNvSpPr txBox="1"/>
          <p:nvPr/>
        </p:nvSpPr>
        <p:spPr>
          <a:xfrm>
            <a:off x="4888164" y="370277"/>
            <a:ext cx="167142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chizophrenia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1" name="Google Shape;191;p11"/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incipal Component Analysis (PCA) plots of the whole set of genes in the dataset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 </a:t>
            </a:r>
            <a:endParaRPr/>
          </a:p>
        </p:txBody>
      </p:sp>
      <p:sp>
        <p:nvSpPr>
          <p:cNvPr id="192" name="Google Shape;192;p11"/>
          <p:cNvSpPr/>
          <p:nvPr/>
        </p:nvSpPr>
        <p:spPr>
          <a:xfrm>
            <a:off x="2510726" y="1462009"/>
            <a:ext cx="1090047" cy="244544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93" name="Google Shape;193;p1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00581" y="1872377"/>
            <a:ext cx="5995419" cy="3113246"/>
          </a:xfrm>
          <a:prstGeom prst="rect">
            <a:avLst/>
          </a:prstGeom>
          <a:noFill/>
          <a:ln>
            <a:noFill/>
          </a:ln>
        </p:spPr>
      </p:pic>
      <p:pic>
        <p:nvPicPr>
          <p:cNvPr id="194" name="Google Shape;194;p11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388685" y="1314718"/>
            <a:ext cx="5511114" cy="459259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Google Shape;199;p12"/>
          <p:cNvSpPr txBox="1"/>
          <p:nvPr/>
        </p:nvSpPr>
        <p:spPr>
          <a:xfrm>
            <a:off x="1823953" y="1026367"/>
            <a:ext cx="3076355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) GSE53987_HPC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00" name="Google Shape;200;p12"/>
          <p:cNvSpPr txBox="1"/>
          <p:nvPr/>
        </p:nvSpPr>
        <p:spPr>
          <a:xfrm>
            <a:off x="4888164" y="370277"/>
            <a:ext cx="1893532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ipolar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01" name="Google Shape;201;p12"/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incipal Component Analysis (PCA) plots of the whole set of genes in the dataset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 </a:t>
            </a:r>
            <a:endParaRPr/>
          </a:p>
        </p:txBody>
      </p:sp>
      <p:sp>
        <p:nvSpPr>
          <p:cNvPr id="202" name="Google Shape;202;p12"/>
          <p:cNvSpPr/>
          <p:nvPr/>
        </p:nvSpPr>
        <p:spPr>
          <a:xfrm>
            <a:off x="2510726" y="1462009"/>
            <a:ext cx="1090047" cy="244544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03" name="Google Shape;203;p12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50899" y="2205817"/>
            <a:ext cx="6024192" cy="3128187"/>
          </a:xfrm>
          <a:prstGeom prst="rect">
            <a:avLst/>
          </a:prstGeom>
          <a:noFill/>
          <a:ln>
            <a:noFill/>
          </a:ln>
        </p:spPr>
      </p:pic>
      <p:pic>
        <p:nvPicPr>
          <p:cNvPr id="204" name="Google Shape;204;p12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302601" y="1102908"/>
            <a:ext cx="5582620" cy="465218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Google Shape;209;p13"/>
          <p:cNvSpPr txBox="1"/>
          <p:nvPr/>
        </p:nvSpPr>
        <p:spPr>
          <a:xfrm>
            <a:off x="1823953" y="1026367"/>
            <a:ext cx="318677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) GSE53987_HPC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0" name="Google Shape;210;p13"/>
          <p:cNvSpPr txBox="1"/>
          <p:nvPr/>
        </p:nvSpPr>
        <p:spPr>
          <a:xfrm>
            <a:off x="4888164" y="370277"/>
            <a:ext cx="302320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ajor Depressive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1" name="Google Shape;211;p13"/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incipal Component Analysis (PCA) plots of the whole set of genes in the dataset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 </a:t>
            </a:r>
            <a:endParaRPr/>
          </a:p>
        </p:txBody>
      </p:sp>
      <p:sp>
        <p:nvSpPr>
          <p:cNvPr id="212" name="Google Shape;212;p13"/>
          <p:cNvSpPr/>
          <p:nvPr/>
        </p:nvSpPr>
        <p:spPr>
          <a:xfrm>
            <a:off x="2510726" y="1462009"/>
            <a:ext cx="1090047" cy="244544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13" name="Google Shape;213;p13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92200" y="2343892"/>
            <a:ext cx="4880395" cy="2534247"/>
          </a:xfrm>
          <a:prstGeom prst="rect">
            <a:avLst/>
          </a:prstGeom>
          <a:noFill/>
          <a:ln>
            <a:noFill/>
          </a:ln>
        </p:spPr>
      </p:pic>
      <p:pic>
        <p:nvPicPr>
          <p:cNvPr id="214" name="Google Shape;214;p13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399764" y="1395699"/>
            <a:ext cx="4952010" cy="412667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Google Shape;219;p14"/>
          <p:cNvSpPr txBox="1"/>
          <p:nvPr/>
        </p:nvSpPr>
        <p:spPr>
          <a:xfrm>
            <a:off x="1823953" y="1026367"/>
            <a:ext cx="323261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) GSE53987_PFC GEO dataset</a:t>
            </a:r>
            <a:endParaRPr sz="1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20" name="Google Shape;220;p14"/>
          <p:cNvSpPr txBox="1"/>
          <p:nvPr/>
        </p:nvSpPr>
        <p:spPr>
          <a:xfrm>
            <a:off x="4888164" y="370277"/>
            <a:ext cx="167142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chizophrenia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21" name="Google Shape;221;p14"/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incipal Component Analysis (PCA) plots of the whole set of genes in the dataset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 </a:t>
            </a:r>
            <a:endParaRPr/>
          </a:p>
        </p:txBody>
      </p:sp>
      <p:sp>
        <p:nvSpPr>
          <p:cNvPr id="222" name="Google Shape;222;p14"/>
          <p:cNvSpPr/>
          <p:nvPr/>
        </p:nvSpPr>
        <p:spPr>
          <a:xfrm>
            <a:off x="2510726" y="1462009"/>
            <a:ext cx="1090047" cy="244544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23" name="Google Shape;223;p14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92200" y="2171700"/>
            <a:ext cx="5359221" cy="2782887"/>
          </a:xfrm>
          <a:prstGeom prst="rect">
            <a:avLst/>
          </a:prstGeom>
          <a:noFill/>
          <a:ln>
            <a:noFill/>
          </a:ln>
        </p:spPr>
      </p:pic>
      <p:pic>
        <p:nvPicPr>
          <p:cNvPr id="224" name="Google Shape;224;p14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5803604" y="1348867"/>
            <a:ext cx="4942180" cy="411848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9" name="Google Shape;229;p15"/>
          <p:cNvSpPr txBox="1"/>
          <p:nvPr/>
        </p:nvSpPr>
        <p:spPr>
          <a:xfrm>
            <a:off x="1823953" y="1026367"/>
            <a:ext cx="323261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) GSE53987_PFC GEO dataset</a:t>
            </a:r>
            <a:endParaRPr sz="1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30" name="Google Shape;230;p15"/>
          <p:cNvSpPr txBox="1"/>
          <p:nvPr/>
        </p:nvSpPr>
        <p:spPr>
          <a:xfrm>
            <a:off x="4888164" y="370277"/>
            <a:ext cx="1917576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ipolar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31" name="Google Shape;231;p15"/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incipal Component Analysis (PCA) plots of the whole set of genes in the dataset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 </a:t>
            </a:r>
            <a:endParaRPr/>
          </a:p>
        </p:txBody>
      </p:sp>
      <p:sp>
        <p:nvSpPr>
          <p:cNvPr id="232" name="Google Shape;232;p15"/>
          <p:cNvSpPr/>
          <p:nvPr/>
        </p:nvSpPr>
        <p:spPr>
          <a:xfrm>
            <a:off x="2510726" y="1462009"/>
            <a:ext cx="1090047" cy="244544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33" name="Google Shape;233;p15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00849" y="2069409"/>
            <a:ext cx="5695151" cy="2957326"/>
          </a:xfrm>
          <a:prstGeom prst="rect">
            <a:avLst/>
          </a:prstGeom>
          <a:noFill/>
          <a:ln>
            <a:noFill/>
          </a:ln>
        </p:spPr>
      </p:pic>
      <p:pic>
        <p:nvPicPr>
          <p:cNvPr id="234" name="Google Shape;234;p15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822911" y="1211033"/>
            <a:ext cx="4968240" cy="41402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Google Shape;239;p16"/>
          <p:cNvSpPr txBox="1"/>
          <p:nvPr/>
        </p:nvSpPr>
        <p:spPr>
          <a:xfrm>
            <a:off x="1823953" y="1026367"/>
            <a:ext cx="323261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) GSE53987_PFC GEO dataset</a:t>
            </a:r>
            <a:endParaRPr sz="1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40" name="Google Shape;240;p16"/>
          <p:cNvSpPr txBox="1"/>
          <p:nvPr/>
        </p:nvSpPr>
        <p:spPr>
          <a:xfrm>
            <a:off x="4888164" y="370277"/>
            <a:ext cx="302320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ajor Depressive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41" name="Google Shape;241;p16"/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incipal Component Analysis (PCA) plots of the whole set of genes in the dataset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 </a:t>
            </a:r>
            <a:endParaRPr/>
          </a:p>
        </p:txBody>
      </p:sp>
      <p:sp>
        <p:nvSpPr>
          <p:cNvPr id="242" name="Google Shape;242;p16"/>
          <p:cNvSpPr/>
          <p:nvPr/>
        </p:nvSpPr>
        <p:spPr>
          <a:xfrm>
            <a:off x="2510726" y="1462009"/>
            <a:ext cx="1090047" cy="244544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43" name="Google Shape;243;p16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83842" y="2119718"/>
            <a:ext cx="5743814" cy="2982595"/>
          </a:xfrm>
          <a:prstGeom prst="rect">
            <a:avLst/>
          </a:prstGeom>
          <a:noFill/>
          <a:ln>
            <a:noFill/>
          </a:ln>
        </p:spPr>
      </p:pic>
      <p:pic>
        <p:nvPicPr>
          <p:cNvPr id="244" name="Google Shape;244;p16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715367" y="1407171"/>
            <a:ext cx="4867246" cy="405603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9" name="Google Shape;249;p17"/>
          <p:cNvSpPr txBox="1"/>
          <p:nvPr/>
        </p:nvSpPr>
        <p:spPr>
          <a:xfrm>
            <a:off x="1823953" y="1026367"/>
            <a:ext cx="308193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q) GSE53987_STR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50" name="Google Shape;250;p17"/>
          <p:cNvSpPr txBox="1"/>
          <p:nvPr/>
        </p:nvSpPr>
        <p:spPr>
          <a:xfrm>
            <a:off x="4888164" y="370277"/>
            <a:ext cx="167142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chizophrenia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51" name="Google Shape;251;p17"/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incipal Component Analysis (PCA) plots of the whole set of genes in the dataset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 </a:t>
            </a:r>
            <a:endParaRPr/>
          </a:p>
        </p:txBody>
      </p:sp>
      <p:sp>
        <p:nvSpPr>
          <p:cNvPr id="252" name="Google Shape;252;p17"/>
          <p:cNvSpPr/>
          <p:nvPr/>
        </p:nvSpPr>
        <p:spPr>
          <a:xfrm>
            <a:off x="2510726" y="1462009"/>
            <a:ext cx="1090047" cy="244544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53" name="Google Shape;253;p17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86639" y="2028278"/>
            <a:ext cx="6096000" cy="3165475"/>
          </a:xfrm>
          <a:prstGeom prst="rect">
            <a:avLst/>
          </a:prstGeom>
          <a:noFill/>
          <a:ln>
            <a:noFill/>
          </a:ln>
        </p:spPr>
      </p:pic>
      <p:pic>
        <p:nvPicPr>
          <p:cNvPr id="254" name="Google Shape;254;p17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559584" y="1026367"/>
            <a:ext cx="5366154" cy="447179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Google Shape;259;p18"/>
          <p:cNvSpPr txBox="1"/>
          <p:nvPr/>
        </p:nvSpPr>
        <p:spPr>
          <a:xfrm>
            <a:off x="1823953" y="1026367"/>
            <a:ext cx="3076355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) GSE53987_HPC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60" name="Google Shape;260;p18"/>
          <p:cNvSpPr txBox="1"/>
          <p:nvPr/>
        </p:nvSpPr>
        <p:spPr>
          <a:xfrm>
            <a:off x="4888164" y="370277"/>
            <a:ext cx="1917576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ipolar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61" name="Google Shape;261;p18"/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incipal Component Analysis (PCA) plots of the whole set of genes in the dataset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 </a:t>
            </a:r>
            <a:endParaRPr/>
          </a:p>
        </p:txBody>
      </p:sp>
      <p:sp>
        <p:nvSpPr>
          <p:cNvPr id="262" name="Google Shape;262;p18"/>
          <p:cNvSpPr/>
          <p:nvPr/>
        </p:nvSpPr>
        <p:spPr>
          <a:xfrm>
            <a:off x="2510726" y="1462009"/>
            <a:ext cx="1090047" cy="244544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63" name="Google Shape;263;p18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92200" y="2121149"/>
            <a:ext cx="5994400" cy="3112717"/>
          </a:xfrm>
          <a:prstGeom prst="rect">
            <a:avLst/>
          </a:prstGeom>
          <a:noFill/>
          <a:ln>
            <a:noFill/>
          </a:ln>
        </p:spPr>
      </p:pic>
      <p:pic>
        <p:nvPicPr>
          <p:cNvPr id="264" name="Google Shape;264;p18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096000" y="1026367"/>
            <a:ext cx="5501640" cy="45847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0" name="Google Shape;270;p19"/>
          <p:cNvSpPr txBox="1"/>
          <p:nvPr/>
        </p:nvSpPr>
        <p:spPr>
          <a:xfrm>
            <a:off x="1823953" y="1026367"/>
            <a:ext cx="3076355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) GSE53987_HPC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71" name="Google Shape;271;p19"/>
          <p:cNvSpPr txBox="1"/>
          <p:nvPr/>
        </p:nvSpPr>
        <p:spPr>
          <a:xfrm>
            <a:off x="4888164" y="370277"/>
            <a:ext cx="302320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ajor Depressive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72" name="Google Shape;272;p19"/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incipal Component Analysis (PCA) plots of the whole set of genes in the dataset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 </a:t>
            </a:r>
            <a:endParaRPr/>
          </a:p>
        </p:txBody>
      </p:sp>
      <p:sp>
        <p:nvSpPr>
          <p:cNvPr id="273" name="Google Shape;273;p19"/>
          <p:cNvSpPr/>
          <p:nvPr/>
        </p:nvSpPr>
        <p:spPr>
          <a:xfrm>
            <a:off x="2510726" y="1462009"/>
            <a:ext cx="1090047" cy="244544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74" name="Google Shape;274;p19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92200" y="2166327"/>
            <a:ext cx="5372100" cy="2789575"/>
          </a:xfrm>
          <a:prstGeom prst="rect">
            <a:avLst/>
          </a:prstGeom>
          <a:noFill/>
          <a:ln>
            <a:noFill/>
          </a:ln>
        </p:spPr>
      </p:pic>
      <p:pic>
        <p:nvPicPr>
          <p:cNvPr id="275" name="Google Shape;275;p19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399764" y="1551778"/>
            <a:ext cx="5163506" cy="430292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Google Shape;98;p2"/>
          <p:cNvSpPr txBox="1"/>
          <p:nvPr/>
        </p:nvSpPr>
        <p:spPr>
          <a:xfrm>
            <a:off x="1823953" y="1026367"/>
            <a:ext cx="261610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) GSE18123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9" name="Google Shape;99;p2"/>
          <p:cNvSpPr txBox="1"/>
          <p:nvPr/>
        </p:nvSpPr>
        <p:spPr>
          <a:xfrm>
            <a:off x="5586626" y="370277"/>
            <a:ext cx="939681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utism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0" name="Google Shape;100;p2"/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incipal Component Analysis (PCA) plots of the whole set of genes in the dataset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 </a:t>
            </a:r>
            <a:endParaRPr/>
          </a:p>
        </p:txBody>
      </p:sp>
      <p:sp>
        <p:nvSpPr>
          <p:cNvPr id="101" name="Google Shape;101;p2"/>
          <p:cNvSpPr/>
          <p:nvPr/>
        </p:nvSpPr>
        <p:spPr>
          <a:xfrm>
            <a:off x="2510726" y="1462009"/>
            <a:ext cx="1090047" cy="244544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02" name="Google Shape;102;p2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87061" y="2045286"/>
            <a:ext cx="5681014" cy="2949985"/>
          </a:xfrm>
          <a:prstGeom prst="rect">
            <a:avLst/>
          </a:prstGeom>
          <a:noFill/>
          <a:ln>
            <a:noFill/>
          </a:ln>
        </p:spPr>
      </p:pic>
      <p:pic>
        <p:nvPicPr>
          <p:cNvPr id="103" name="Google Shape;103;p2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323927" y="1314400"/>
            <a:ext cx="5075040" cy="42292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Google Shape;108;p3"/>
          <p:cNvSpPr txBox="1"/>
          <p:nvPr/>
        </p:nvSpPr>
        <p:spPr>
          <a:xfrm>
            <a:off x="1823952" y="1026367"/>
            <a:ext cx="306421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) GSE25507 GEO dataset</a:t>
            </a:r>
            <a:endParaRPr sz="1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9" name="Google Shape;109;p3"/>
          <p:cNvSpPr txBox="1"/>
          <p:nvPr/>
        </p:nvSpPr>
        <p:spPr>
          <a:xfrm>
            <a:off x="4888164" y="370277"/>
            <a:ext cx="1944436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utism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0" name="Google Shape;110;p3"/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incipal Component Analysis (PCA) plots of the whole set of genes in the dataset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 </a:t>
            </a:r>
            <a:endParaRPr/>
          </a:p>
        </p:txBody>
      </p:sp>
      <p:sp>
        <p:nvSpPr>
          <p:cNvPr id="111" name="Google Shape;111;p3"/>
          <p:cNvSpPr/>
          <p:nvPr/>
        </p:nvSpPr>
        <p:spPr>
          <a:xfrm>
            <a:off x="2510726" y="1462009"/>
            <a:ext cx="1090047" cy="244544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12" name="Google Shape;112;p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600175" y="2054250"/>
            <a:ext cx="5468050" cy="2839401"/>
          </a:xfrm>
          <a:prstGeom prst="rect">
            <a:avLst/>
          </a:prstGeom>
          <a:noFill/>
          <a:ln>
            <a:noFill/>
          </a:ln>
        </p:spPr>
      </p:pic>
      <p:pic>
        <p:nvPicPr>
          <p:cNvPr id="113" name="Google Shape;113;p3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6220625" y="922787"/>
            <a:ext cx="5818977" cy="484914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Google Shape;118;p4"/>
          <p:cNvSpPr txBox="1"/>
          <p:nvPr/>
        </p:nvSpPr>
        <p:spPr>
          <a:xfrm>
            <a:off x="1823953" y="1026367"/>
            <a:ext cx="261610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) GSE17612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9" name="Google Shape;119;p4"/>
          <p:cNvSpPr txBox="1"/>
          <p:nvPr/>
        </p:nvSpPr>
        <p:spPr>
          <a:xfrm>
            <a:off x="4888164" y="370277"/>
            <a:ext cx="167142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chizophrenia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0" name="Google Shape;120;p4"/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incipal Component Analysis (PCA) plots of the whole set of genes in the dataset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 </a:t>
            </a:r>
            <a:endParaRPr/>
          </a:p>
        </p:txBody>
      </p:sp>
      <p:sp>
        <p:nvSpPr>
          <p:cNvPr id="121" name="Google Shape;121;p4"/>
          <p:cNvSpPr/>
          <p:nvPr/>
        </p:nvSpPr>
        <p:spPr>
          <a:xfrm>
            <a:off x="2510726" y="1462009"/>
            <a:ext cx="1090047" cy="244544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22" name="Google Shape;122;p4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09936" y="1991635"/>
            <a:ext cx="5887653" cy="3057286"/>
          </a:xfrm>
          <a:prstGeom prst="rect">
            <a:avLst/>
          </a:prstGeom>
          <a:noFill/>
          <a:ln>
            <a:noFill/>
          </a:ln>
        </p:spPr>
      </p:pic>
      <p:pic>
        <p:nvPicPr>
          <p:cNvPr id="123" name="Google Shape;123;p4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323893" y="1026367"/>
            <a:ext cx="5740400" cy="4783667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Google Shape;129;p5"/>
          <p:cNvSpPr txBox="1"/>
          <p:nvPr/>
        </p:nvSpPr>
        <p:spPr>
          <a:xfrm>
            <a:off x="1823953" y="1026367"/>
            <a:ext cx="260808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) GSE62333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0" name="Google Shape;130;p5"/>
          <p:cNvSpPr txBox="1"/>
          <p:nvPr/>
        </p:nvSpPr>
        <p:spPr>
          <a:xfrm>
            <a:off x="4888164" y="370277"/>
            <a:ext cx="167142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chizophrenia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1" name="Google Shape;131;p5"/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incipal Component Analysis (PCA) plots of the whole set of genes in the dataset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 </a:t>
            </a:r>
            <a:endParaRPr/>
          </a:p>
        </p:txBody>
      </p:sp>
      <p:sp>
        <p:nvSpPr>
          <p:cNvPr id="132" name="Google Shape;132;p5"/>
          <p:cNvSpPr/>
          <p:nvPr/>
        </p:nvSpPr>
        <p:spPr>
          <a:xfrm>
            <a:off x="2510726" y="1462009"/>
            <a:ext cx="1090047" cy="244544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33" name="Google Shape;133;p5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31412" y="1810249"/>
            <a:ext cx="6316116" cy="3279775"/>
          </a:xfrm>
          <a:prstGeom prst="rect">
            <a:avLst/>
          </a:prstGeom>
          <a:noFill/>
          <a:ln>
            <a:noFill/>
          </a:ln>
        </p:spPr>
      </p:pic>
      <p:pic>
        <p:nvPicPr>
          <p:cNvPr id="134" name="Google Shape;134;p5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559584" y="1068357"/>
            <a:ext cx="4826000" cy="4021667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Google Shape;139;p6"/>
          <p:cNvSpPr txBox="1"/>
          <p:nvPr/>
        </p:nvSpPr>
        <p:spPr>
          <a:xfrm>
            <a:off x="1823953" y="1026367"/>
            <a:ext cx="245278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) GSE5389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0" name="Google Shape;140;p6"/>
          <p:cNvSpPr txBox="1"/>
          <p:nvPr/>
        </p:nvSpPr>
        <p:spPr>
          <a:xfrm>
            <a:off x="4888164" y="370277"/>
            <a:ext cx="1893532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ipolar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1" name="Google Shape;141;p6"/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incipal Component Analysis (PCA) plots of the whole set of genes in the dataset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 </a:t>
            </a:r>
            <a:endParaRPr/>
          </a:p>
        </p:txBody>
      </p:sp>
      <p:sp>
        <p:nvSpPr>
          <p:cNvPr id="142" name="Google Shape;142;p6"/>
          <p:cNvSpPr/>
          <p:nvPr/>
        </p:nvSpPr>
        <p:spPr>
          <a:xfrm>
            <a:off x="2510726" y="1462009"/>
            <a:ext cx="1090047" cy="244544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43" name="Google Shape;143;p6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858953"/>
            <a:ext cx="6316915" cy="3280190"/>
          </a:xfrm>
          <a:prstGeom prst="rect">
            <a:avLst/>
          </a:prstGeom>
          <a:noFill/>
          <a:ln>
            <a:noFill/>
          </a:ln>
        </p:spPr>
      </p:pic>
      <p:pic>
        <p:nvPicPr>
          <p:cNvPr id="144" name="Google Shape;144;p6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6621715" y="922787"/>
            <a:ext cx="5417883" cy="451490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Google Shape;149;p7"/>
          <p:cNvSpPr txBox="1"/>
          <p:nvPr/>
        </p:nvSpPr>
        <p:spPr>
          <a:xfrm>
            <a:off x="1823953" y="1026367"/>
            <a:ext cx="2484655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) GSE7036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0" name="Google Shape;150;p7"/>
          <p:cNvSpPr txBox="1"/>
          <p:nvPr/>
        </p:nvSpPr>
        <p:spPr>
          <a:xfrm>
            <a:off x="4888164" y="370277"/>
            <a:ext cx="1893532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ipolar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1" name="Google Shape;151;p7"/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incipal Component Analysis (PCA) plots of the whole set of genes in the dataset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 </a:t>
            </a:r>
            <a:endParaRPr/>
          </a:p>
        </p:txBody>
      </p:sp>
      <p:sp>
        <p:nvSpPr>
          <p:cNvPr id="152" name="Google Shape;152;p7"/>
          <p:cNvSpPr/>
          <p:nvPr/>
        </p:nvSpPr>
        <p:spPr>
          <a:xfrm>
            <a:off x="2510726" y="1462009"/>
            <a:ext cx="1090047" cy="244544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53" name="Google Shape;153;p7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32509" y="2001920"/>
            <a:ext cx="5848039" cy="3036716"/>
          </a:xfrm>
          <a:prstGeom prst="rect">
            <a:avLst/>
          </a:prstGeom>
          <a:noFill/>
          <a:ln>
            <a:noFill/>
          </a:ln>
        </p:spPr>
      </p:pic>
      <p:pic>
        <p:nvPicPr>
          <p:cNvPr id="154" name="Google Shape;154;p7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437086" y="1211033"/>
            <a:ext cx="5076922" cy="423076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Google Shape;159;p8"/>
          <p:cNvSpPr txBox="1"/>
          <p:nvPr/>
        </p:nvSpPr>
        <p:spPr>
          <a:xfrm>
            <a:off x="1823953" y="1026367"/>
            <a:ext cx="261610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) GSE12654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0" name="Google Shape;160;p8"/>
          <p:cNvSpPr txBox="1"/>
          <p:nvPr/>
        </p:nvSpPr>
        <p:spPr>
          <a:xfrm>
            <a:off x="5472458" y="370277"/>
            <a:ext cx="1671419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chizophrenia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1" name="Google Shape;161;p8"/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incipal Component Analysis (PCA) plots of the whole set of genes in the dataset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 </a:t>
            </a:r>
            <a:endParaRPr/>
          </a:p>
        </p:txBody>
      </p:sp>
      <p:sp>
        <p:nvSpPr>
          <p:cNvPr id="162" name="Google Shape;162;p8"/>
          <p:cNvSpPr/>
          <p:nvPr/>
        </p:nvSpPr>
        <p:spPr>
          <a:xfrm>
            <a:off x="2510726" y="1462009"/>
            <a:ext cx="1090047" cy="244544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63" name="Google Shape;163;p8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00948" y="2203371"/>
            <a:ext cx="5677716" cy="2948272"/>
          </a:xfrm>
          <a:prstGeom prst="rect">
            <a:avLst/>
          </a:prstGeom>
          <a:noFill/>
          <a:ln>
            <a:noFill/>
          </a:ln>
        </p:spPr>
      </p:pic>
      <p:pic>
        <p:nvPicPr>
          <p:cNvPr id="164" name="Google Shape;164;p8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253246" y="1257300"/>
            <a:ext cx="5320804" cy="443400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Google Shape;169;p9"/>
          <p:cNvSpPr txBox="1"/>
          <p:nvPr/>
        </p:nvSpPr>
        <p:spPr>
          <a:xfrm>
            <a:off x="1823953" y="1026367"/>
            <a:ext cx="256980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) GSE12654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0" name="Google Shape;170;p9"/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incipal Component Analysis (PCA) plots of the whole set of genes in the dataset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 </a:t>
            </a:r>
            <a:endParaRPr/>
          </a:p>
        </p:txBody>
      </p:sp>
      <p:sp>
        <p:nvSpPr>
          <p:cNvPr id="171" name="Google Shape;171;p9"/>
          <p:cNvSpPr/>
          <p:nvPr/>
        </p:nvSpPr>
        <p:spPr>
          <a:xfrm>
            <a:off x="2510726" y="1462009"/>
            <a:ext cx="1090047" cy="244544"/>
          </a:xfrm>
          <a:prstGeom prst="rect">
            <a:avLst/>
          </a:prstGeom>
          <a:solidFill>
            <a:schemeClr val="lt1"/>
          </a:solidFill>
          <a:ln w="127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2" name="Google Shape;172;p9"/>
          <p:cNvSpPr txBox="1"/>
          <p:nvPr/>
        </p:nvSpPr>
        <p:spPr>
          <a:xfrm>
            <a:off x="5361404" y="370277"/>
            <a:ext cx="1893532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ipolar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73" name="Google Shape;173;p9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86639" y="1937541"/>
            <a:ext cx="6096000" cy="3165475"/>
          </a:xfrm>
          <a:prstGeom prst="rect">
            <a:avLst/>
          </a:prstGeom>
          <a:noFill/>
          <a:ln>
            <a:noFill/>
          </a:ln>
        </p:spPr>
      </p:pic>
      <p:pic>
        <p:nvPicPr>
          <p:cNvPr id="174" name="Google Shape;174;p9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553200" y="1026367"/>
            <a:ext cx="5130800" cy="4275667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91</Words>
  <Application>Microsoft Office PowerPoint</Application>
  <PresentationFormat>Panorámica</PresentationFormat>
  <Paragraphs>60</Paragraphs>
  <Slides>19</Slides>
  <Notes>19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9</vt:i4>
      </vt:variant>
    </vt:vector>
  </HeadingPairs>
  <TitlesOfParts>
    <vt:vector size="22" baseType="lpstr">
      <vt:lpstr>Arial</vt:lpstr>
      <vt:lpstr>Calibri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Windows User</dc:creator>
  <cp:lastModifiedBy>Windows User</cp:lastModifiedBy>
  <cp:revision>1</cp:revision>
  <dcterms:created xsi:type="dcterms:W3CDTF">2024-05-16T14:56:22Z</dcterms:created>
  <dcterms:modified xsi:type="dcterms:W3CDTF">2024-10-16T10:30:09Z</dcterms:modified>
</cp:coreProperties>
</file>